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xmlns="" id="{892E9912-48E6-8741-98FC-B47DE27D9B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9732961"/>
              </p:ext>
            </p:extLst>
          </p:nvPr>
        </p:nvGraphicFramePr>
        <p:xfrm>
          <a:off x="2808799" y="1617024"/>
          <a:ext cx="6410412" cy="320844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533760">
                  <a:extLst>
                    <a:ext uri="{9D8B030D-6E8A-4147-A177-3AD203B41FA5}">
                      <a16:colId xmlns:a16="http://schemas.microsoft.com/office/drawing/2014/main" xmlns="" val="2347055275"/>
                    </a:ext>
                  </a:extLst>
                </a:gridCol>
                <a:gridCol w="1922258">
                  <a:extLst>
                    <a:ext uri="{9D8B030D-6E8A-4147-A177-3AD203B41FA5}">
                      <a16:colId xmlns:a16="http://schemas.microsoft.com/office/drawing/2014/main" xmlns="" val="2615539536"/>
                    </a:ext>
                  </a:extLst>
                </a:gridCol>
                <a:gridCol w="954394">
                  <a:extLst>
                    <a:ext uri="{9D8B030D-6E8A-4147-A177-3AD203B41FA5}">
                      <a16:colId xmlns:a16="http://schemas.microsoft.com/office/drawing/2014/main" xmlns="" val="581839703"/>
                    </a:ext>
                  </a:extLst>
                </a:gridCol>
              </a:tblGrid>
              <a:tr h="6416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Biomarkers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Adjust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*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HR [95% CI]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18337698"/>
                  </a:ext>
                </a:extLst>
              </a:tr>
              <a:tr h="6416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Baseline IL-6, </a:t>
                      </a:r>
                      <a:r>
                        <a:rPr lang="fr-FR" sz="1400" b="0" dirty="0" err="1">
                          <a:solidFill>
                            <a:schemeClr val="tx1"/>
                          </a:solidFill>
                          <a:effectLst/>
                        </a:rPr>
                        <a:t>pg</a:t>
                      </a:r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/ml (log) </a:t>
                      </a:r>
                      <a:endParaRPr lang="fr-FR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2.20 [1.58 - 3.05 ]</a:t>
                      </a:r>
                      <a:endParaRPr lang="fr-FR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b="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endParaRPr lang="fr-FR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29653207"/>
                  </a:ext>
                </a:extLst>
              </a:tr>
              <a:tr h="6416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Baseline CRP, per 50 mg/l increase  </a:t>
                      </a:r>
                      <a:endParaRPr lang="fr-FR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1.28 [ 1.00 - 1.64 ]</a:t>
                      </a:r>
                      <a:endParaRPr lang="fr-FR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0.05</a:t>
                      </a:r>
                      <a:endParaRPr lang="fr-FR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73664567"/>
                  </a:ext>
                </a:extLst>
              </a:tr>
              <a:tr h="6416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Baseline lymphocytes per 100/mm3 increase</a:t>
                      </a:r>
                      <a:endParaRPr lang="fr-FR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0.91 [0.81 - 1.02]</a:t>
                      </a:r>
                      <a:endParaRPr lang="fr-FR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0.10</a:t>
                      </a:r>
                      <a:endParaRPr lang="fr-FR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97846136"/>
                  </a:ext>
                </a:extLst>
              </a:tr>
              <a:tr h="641689">
                <a:tc>
                  <a:txBody>
                    <a:bodyPr/>
                    <a:lstStyle/>
                    <a:p>
                      <a:pPr algn="just"/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Baseline fibrinogen per g/l </a:t>
                      </a: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1.16 [0.83-1.61]</a:t>
                      </a: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0" dirty="0">
                          <a:solidFill>
                            <a:schemeClr val="tx1"/>
                          </a:solidFill>
                          <a:effectLst/>
                        </a:rPr>
                        <a:t>0.37</a:t>
                      </a: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46181800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3B0B1E28-D49F-4F49-9825-121CEEEB6373}"/>
              </a:ext>
            </a:extLst>
          </p:cNvPr>
          <p:cNvSpPr txBox="1"/>
          <p:nvPr/>
        </p:nvSpPr>
        <p:spPr>
          <a:xfrm>
            <a:off x="596583" y="5723907"/>
            <a:ext cx="112380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dditional  file 9</a:t>
            </a:r>
            <a:r>
              <a:rPr lang="en-GB" dirty="0"/>
              <a:t>.</a:t>
            </a:r>
            <a:r>
              <a:rPr lang="en-US" dirty="0"/>
              <a:t> Predictive value of biomarkers (Day 0) for in-ICU mortality. For each biomarker, adjustment was done on SOFA at ICU admission and time from symptom onset to dosage. HR, Hazard Ratio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088380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101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12:25Z</dcterms:modified>
</cp:coreProperties>
</file>